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DA396-33A7-4D8E-819C-CB2F678741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7C6C1-C722-415F-B138-6DCC0AF4C6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C9656-2546-4CAD-942E-3B8D0FD6A8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1DE23-8C2D-4E89-8BC9-D827DF34DB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3B523-096E-429D-BDC2-2E6D5CA565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35BB4E-2C97-4A1E-A0E4-EDFBA32462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EA7E5B-286A-41AA-843D-787D60EE76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90A86-63B9-438E-881B-9EF69314CD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60137-F98E-4D3C-AE0F-89B63A09EE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66BF1-1B0A-45AF-8B19-92F4119D7E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35E5E-CAB0-4A53-B777-85BFB73E6F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7F328-1C27-4C4C-933C-3A0863653B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75EE3F-990C-4130-896F-771D2C16DA3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763560" y="380880"/>
            <a:ext cx="609444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304920" y="457200"/>
            <a:ext cx="626904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304920" y="457200"/>
            <a:ext cx="6156360" cy="8077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0" y="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0" y="304920"/>
            <a:ext cx="3584520" cy="464796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2"/>
          <a:stretch/>
        </p:blipFill>
        <p:spPr>
          <a:xfrm>
            <a:off x="3657600" y="304920"/>
            <a:ext cx="2870280" cy="26971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3733920" y="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0" y="5943600"/>
            <a:ext cx="2779560" cy="123048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 flipV="1" rot="10739400">
            <a:off x="0" y="55627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4"/>
          <a:stretch/>
        </p:blipFill>
        <p:spPr>
          <a:xfrm>
            <a:off x="2803680" y="3581280"/>
            <a:ext cx="4054320" cy="510552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3733920" y="3200400"/>
            <a:ext cx="7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581280" y="0"/>
            <a:ext cx="60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0" y="304920"/>
            <a:ext cx="3397320" cy="29001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"/>
          <a:stretch/>
        </p:blipFill>
        <p:spPr>
          <a:xfrm>
            <a:off x="3941640" y="304920"/>
            <a:ext cx="2916360" cy="36525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0" y="335268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505320" y="419112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3"/>
          <a:stretch/>
        </p:blipFill>
        <p:spPr>
          <a:xfrm>
            <a:off x="380880" y="3429000"/>
            <a:ext cx="2895840" cy="116532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4"/>
          <a:stretch/>
        </p:blipFill>
        <p:spPr>
          <a:xfrm>
            <a:off x="3081240" y="4572000"/>
            <a:ext cx="3776760" cy="45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8T23:53:00Z</dcterms:created>
  <dc:creator>Ming Yi</dc:creator>
  <dc:description/>
  <dc:language>en-US</dc:language>
  <cp:lastModifiedBy>Ming Yi</cp:lastModifiedBy>
  <dcterms:modified xsi:type="dcterms:W3CDTF">2012-02-09T07:10:47Z</dcterms:modified>
  <cp:revision>9</cp:revision>
  <dc:subject/>
  <dc:title>Slide 1</dc:title>
</cp:coreProperties>
</file>